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6281"/>
  </p:normalViewPr>
  <p:slideViewPr>
    <p:cSldViewPr snapToGrid="0" snapToObjects="1">
      <p:cViewPr varScale="1">
        <p:scale>
          <a:sx n="121" d="100"/>
          <a:sy n="121" d="100"/>
        </p:scale>
        <p:origin x="2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264394-9C9A-B543-9145-5B6694020796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C498B7-416B-D74A-A654-757274E1B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9165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Association between number of publications per country and median index of citation per Non-US Country. Spearman’s correlation was used to evaluate associations and reported as coefficients (r) and p-values (p). The blue solid line represents the loess curve fitted to the data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CD67CD-DF58-1F4A-9EF0-FFDFA04A55C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578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18F40A-F6D4-A54D-B924-B0E1F84DDC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A554AB-818C-EF4C-B622-545DDBC9D3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4EF805-FF5C-AE47-B8C3-A1BD92D5F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2DDF63-9C3B-4848-8329-91D39B771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9B6A2C-865E-E546-990D-FBF8FF597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26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30385F-6EB7-5545-85CB-404CA0110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4CE0D7-AE84-C846-AC92-5E2FDA8BB6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52E4CC-0A51-2147-A62F-BAC5749F4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20D02E-43D8-A34F-B630-62491548D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8F1E63-47D1-4D41-B774-910E7BB28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575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C962475-BED5-F142-B16A-0B01020009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AE3EA3-8F10-A44B-A463-D483780D3E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17C979-8BD8-8C46-B693-4AFF6A988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4762B4-E2A8-444C-A06B-B05D867B9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471CCD-346B-CA42-930C-4D0226DAA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865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614360-3D15-7E40-8FA3-43BCBB923A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6CD94B-A040-4F4C-BE53-BB2E053410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B643F3-07E9-834D-A232-9DB276B99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25F752-1554-0F46-8A47-431F8B497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4BEE52-832E-A243-997D-2F2E8470F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930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45BB9-6427-AF40-8B75-F5C998BC29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9F62DC-618F-E04E-AC1F-C486DC9888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DF2600-2AB4-1C4C-8812-58C4EEB04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3AB38B-37B6-8B46-9199-689FAFF8B4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7944A1-69EB-654E-843E-68B2B4F93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107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B14390-BB4E-9A41-8261-69368E8833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374004-9582-C64D-BD3C-493E8FF7A2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BEB474-A9C5-F648-B5FE-8E34E0729F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6B6121-3289-2746-98AB-734D529C2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30F0A0-3647-054A-A317-A0DE5722A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CB9842-FB8E-CB49-B784-6D8D98A91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044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029ED4-671D-8D4B-BBA4-8B5E8F12E2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A95948-338F-D348-BC88-11EAA55F8C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95F04B-69E1-0145-A6D8-6294F6130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C1F5ED-4BC9-B647-ADE9-44A4E455B5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DB7BEC-D151-684B-B246-C14E2EB9CC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CBD180-E041-F344-A40D-2630E2625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0B1233-BB4F-4E4E-B630-96237B5C2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CC4923-A4EE-D247-8B35-5354ECB5E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422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AF486-E0DC-7141-BE6B-BFEE123FA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19A5F-8428-534E-826E-75E9BE09B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9D2877-E6F8-E642-8D9D-17E0065F2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18810F2-2366-FA47-A5E8-F224FF59E5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251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7E76D3-F923-A54F-8E43-B23380FD7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BFD029-D8A4-344B-AC8C-79DD749C6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7887A3-8181-DB43-9416-A4AB79708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167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680DDC-48C2-F34D-8D05-C915040CB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9273B3-EDB4-7A41-9BD4-7E1CFCAA3F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D81CE2-3935-F740-A44D-2EAB88F424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B79E3D-B215-E34E-974F-2D03E52B1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440897-84AF-D146-B165-2C6AA9BA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CFC9F5-6419-1742-8798-53B1D21B5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561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9A0516-AEC8-BF40-AC89-C17DA10067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C81553F-0172-0547-8487-747D1F9F78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A7DCBC-EC81-8947-8E24-65E496D7F9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D7085A-1DEA-894C-8669-DBE987BBE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E206EC-4AEA-E44E-8228-05C41AB50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B8FD9A-A0A6-2242-8276-48257C253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686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C03BA7D-4B53-5248-ACE3-1C6ADC9054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4A6A03-A98C-854C-AC3C-8F410B9DD4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688AE2-2EDC-EF4D-9E6F-9BBF0C6064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0077B-C1C3-224F-84BC-E476112F6C55}" type="datetimeFigureOut">
              <a:rPr lang="en-US" smtClean="0"/>
              <a:t>10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F758A3-1E55-8A4F-B809-3922ABD535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A62C3-7BAD-B140-99BC-9281C50239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334506-D3DF-F041-88F1-ED25D906A3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452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10389926-2381-FB48-97AB-5B0E83CE80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0F510E4-4C91-9148-84D1-1D2583D0FCA2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620" y="984642"/>
            <a:ext cx="6232634" cy="53941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851C7A4-4D4B-6647-B807-CE3E70BB27B2}"/>
              </a:ext>
            </a:extLst>
          </p:cNvPr>
          <p:cNvSpPr txBox="1"/>
          <p:nvPr/>
        </p:nvSpPr>
        <p:spPr>
          <a:xfrm>
            <a:off x="819807" y="6231614"/>
            <a:ext cx="1006150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Association between number of publications per country and median index of citation per Non-US Country. Spearman’s correlation was used to evaluate associations and reported as coefficients (r) and p-values (p). The blue solid line represents the loess curve fitted to the data.</a:t>
            </a:r>
            <a:endParaRPr lang="en-US" altLang="en-US" sz="1000" dirty="0">
              <a:latin typeface="Arial" panose="020B0604020202020204" pitchFamily="34" charset="0"/>
            </a:endParaRPr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382605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03</Words>
  <Application>Microsoft Macintosh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gan Corey</dc:creator>
  <cp:lastModifiedBy>Logan Corey</cp:lastModifiedBy>
  <cp:revision>5</cp:revision>
  <dcterms:created xsi:type="dcterms:W3CDTF">2021-10-09T14:16:11Z</dcterms:created>
  <dcterms:modified xsi:type="dcterms:W3CDTF">2021-10-23T18:30:27Z</dcterms:modified>
</cp:coreProperties>
</file>